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17"/>
    <p:restoredTop sz="95306" autoAdjust="0"/>
  </p:normalViewPr>
  <p:slideViewPr>
    <p:cSldViewPr snapToGrid="0" snapToObjects="1">
      <p:cViewPr>
        <p:scale>
          <a:sx n="169" d="100"/>
          <a:sy n="169" d="100"/>
        </p:scale>
        <p:origin x="1408" y="-449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FEB6C1-B421-7849-B659-7515545E4A2F}" type="datetimeFigureOut">
              <a:rPr lang="en-US" smtClean="0"/>
              <a:t>10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0DD332-D782-A04F-802C-D2AFFFCE2F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987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CDCE0B-24C3-7145-9E4F-7E2C91549890}" type="slidenum">
              <a:rPr lang="en-US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90492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7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51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03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55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207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259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31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36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415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7400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8953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6"/>
            <a:ext cx="1748790" cy="85822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6"/>
            <a:ext cx="5116830" cy="85822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695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8655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3"/>
            <a:ext cx="6606540" cy="2200274"/>
          </a:xfrm>
        </p:spPr>
        <p:txBody>
          <a:bodyPr anchor="b"/>
          <a:lstStyle>
            <a:lvl1pPr marL="0" indent="0">
              <a:buNone/>
              <a:defRPr sz="1798">
                <a:solidFill>
                  <a:schemeClr val="tx1">
                    <a:tint val="75000"/>
                  </a:schemeClr>
                </a:solidFill>
              </a:defRPr>
            </a:lvl1pPr>
            <a:lvl2pPr marL="4051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03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559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207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2598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311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3637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4157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4479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5"/>
            <a:ext cx="3432810" cy="6638079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79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5"/>
            <a:ext cx="3432810" cy="6638079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79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6806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501"/>
            <a:ext cx="3434160" cy="938317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5196" indent="0">
              <a:buNone/>
              <a:defRPr sz="1798" b="1"/>
            </a:lvl2pPr>
            <a:lvl3pPr marL="810394" indent="0">
              <a:buNone/>
              <a:defRPr sz="1600" b="1"/>
            </a:lvl3pPr>
            <a:lvl4pPr marL="1215590" indent="0">
              <a:buNone/>
              <a:defRPr sz="1400" b="1"/>
            </a:lvl4pPr>
            <a:lvl5pPr marL="1620786" indent="0">
              <a:buNone/>
              <a:defRPr sz="1400" b="1"/>
            </a:lvl5pPr>
            <a:lvl6pPr marL="2025983" indent="0">
              <a:buNone/>
              <a:defRPr sz="1400" b="1"/>
            </a:lvl6pPr>
            <a:lvl7pPr marL="2431180" indent="0">
              <a:buNone/>
              <a:defRPr sz="1400" b="1"/>
            </a:lvl7pPr>
            <a:lvl8pPr marL="2836377" indent="0">
              <a:buNone/>
              <a:defRPr sz="1400" b="1"/>
            </a:lvl8pPr>
            <a:lvl9pPr marL="3241573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8"/>
            <a:ext cx="3434160" cy="5795223"/>
          </a:xfrm>
        </p:spPr>
        <p:txBody>
          <a:bodyPr/>
          <a:lstStyle>
            <a:lvl1pPr>
              <a:defRPr sz="2100"/>
            </a:lvl1pPr>
            <a:lvl2pPr>
              <a:defRPr sz="1798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6" y="2251501"/>
            <a:ext cx="3435509" cy="938317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5196" indent="0">
              <a:buNone/>
              <a:defRPr sz="1798" b="1"/>
            </a:lvl2pPr>
            <a:lvl3pPr marL="810394" indent="0">
              <a:buNone/>
              <a:defRPr sz="1600" b="1"/>
            </a:lvl3pPr>
            <a:lvl4pPr marL="1215590" indent="0">
              <a:buNone/>
              <a:defRPr sz="1400" b="1"/>
            </a:lvl4pPr>
            <a:lvl5pPr marL="1620786" indent="0">
              <a:buNone/>
              <a:defRPr sz="1400" b="1"/>
            </a:lvl5pPr>
            <a:lvl6pPr marL="2025983" indent="0">
              <a:buNone/>
              <a:defRPr sz="1400" b="1"/>
            </a:lvl6pPr>
            <a:lvl7pPr marL="2431180" indent="0">
              <a:buNone/>
              <a:defRPr sz="1400" b="1"/>
            </a:lvl7pPr>
            <a:lvl8pPr marL="2836377" indent="0">
              <a:buNone/>
              <a:defRPr sz="1400" b="1"/>
            </a:lvl8pPr>
            <a:lvl9pPr marL="3241573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6" y="3189818"/>
            <a:ext cx="3435509" cy="5795223"/>
          </a:xfrm>
        </p:spPr>
        <p:txBody>
          <a:bodyPr/>
          <a:lstStyle>
            <a:lvl1pPr>
              <a:defRPr sz="2100"/>
            </a:lvl1pPr>
            <a:lvl2pPr>
              <a:defRPr sz="1798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777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8406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29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3"/>
            <a:ext cx="2557066" cy="1704340"/>
          </a:xfrm>
        </p:spPr>
        <p:txBody>
          <a:bodyPr anchor="b"/>
          <a:lstStyle>
            <a:lvl1pPr algn="l">
              <a:defRPr sz="179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7"/>
            <a:ext cx="4344988" cy="8584566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798"/>
            </a:lvl4pPr>
            <a:lvl5pPr>
              <a:defRPr sz="1798"/>
            </a:lvl5pPr>
            <a:lvl6pPr>
              <a:defRPr sz="1798"/>
            </a:lvl6pPr>
            <a:lvl7pPr>
              <a:defRPr sz="1798"/>
            </a:lvl7pPr>
            <a:lvl8pPr>
              <a:defRPr sz="1798"/>
            </a:lvl8pPr>
            <a:lvl9pPr>
              <a:defRPr sz="17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7"/>
            <a:ext cx="2557066" cy="6880226"/>
          </a:xfrm>
        </p:spPr>
        <p:txBody>
          <a:bodyPr/>
          <a:lstStyle>
            <a:lvl1pPr marL="0" indent="0">
              <a:buNone/>
              <a:defRPr sz="1200"/>
            </a:lvl1pPr>
            <a:lvl2pPr marL="405196" indent="0">
              <a:buNone/>
              <a:defRPr sz="1098"/>
            </a:lvl2pPr>
            <a:lvl3pPr marL="810394" indent="0">
              <a:buNone/>
              <a:defRPr sz="900"/>
            </a:lvl3pPr>
            <a:lvl4pPr marL="1215590" indent="0">
              <a:buNone/>
              <a:defRPr sz="801"/>
            </a:lvl4pPr>
            <a:lvl5pPr marL="1620786" indent="0">
              <a:buNone/>
              <a:defRPr sz="801"/>
            </a:lvl5pPr>
            <a:lvl6pPr marL="2025983" indent="0">
              <a:buNone/>
              <a:defRPr sz="801"/>
            </a:lvl6pPr>
            <a:lvl7pPr marL="2431180" indent="0">
              <a:buNone/>
              <a:defRPr sz="801"/>
            </a:lvl7pPr>
            <a:lvl8pPr marL="2836377" indent="0">
              <a:buNone/>
              <a:defRPr sz="801"/>
            </a:lvl8pPr>
            <a:lvl9pPr marL="3241573" indent="0">
              <a:buNone/>
              <a:defRPr sz="8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875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179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2800"/>
            </a:lvl1pPr>
            <a:lvl2pPr marL="405196" indent="0">
              <a:buNone/>
              <a:defRPr sz="2500"/>
            </a:lvl2pPr>
            <a:lvl3pPr marL="810394" indent="0">
              <a:buNone/>
              <a:defRPr sz="2100"/>
            </a:lvl3pPr>
            <a:lvl4pPr marL="1215590" indent="0">
              <a:buNone/>
              <a:defRPr sz="1798"/>
            </a:lvl4pPr>
            <a:lvl5pPr marL="1620786" indent="0">
              <a:buNone/>
              <a:defRPr sz="1798"/>
            </a:lvl5pPr>
            <a:lvl6pPr marL="2025983" indent="0">
              <a:buNone/>
              <a:defRPr sz="1798"/>
            </a:lvl6pPr>
            <a:lvl7pPr marL="2431180" indent="0">
              <a:buNone/>
              <a:defRPr sz="1798"/>
            </a:lvl7pPr>
            <a:lvl8pPr marL="2836377" indent="0">
              <a:buNone/>
              <a:defRPr sz="1798"/>
            </a:lvl8pPr>
            <a:lvl9pPr marL="3241573" indent="0">
              <a:buNone/>
              <a:defRPr sz="1798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200"/>
            </a:lvl1pPr>
            <a:lvl2pPr marL="405196" indent="0">
              <a:buNone/>
              <a:defRPr sz="1098"/>
            </a:lvl2pPr>
            <a:lvl3pPr marL="810394" indent="0">
              <a:buNone/>
              <a:defRPr sz="900"/>
            </a:lvl3pPr>
            <a:lvl4pPr marL="1215590" indent="0">
              <a:buNone/>
              <a:defRPr sz="801"/>
            </a:lvl4pPr>
            <a:lvl5pPr marL="1620786" indent="0">
              <a:buNone/>
              <a:defRPr sz="801"/>
            </a:lvl5pPr>
            <a:lvl6pPr marL="2025983" indent="0">
              <a:buNone/>
              <a:defRPr sz="801"/>
            </a:lvl6pPr>
            <a:lvl7pPr marL="2431180" indent="0">
              <a:buNone/>
              <a:defRPr sz="801"/>
            </a:lvl7pPr>
            <a:lvl8pPr marL="2836377" indent="0">
              <a:buNone/>
              <a:defRPr sz="801"/>
            </a:lvl8pPr>
            <a:lvl9pPr marL="3241573" indent="0">
              <a:buNone/>
              <a:defRPr sz="8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7198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3"/>
            <a:ext cx="6995160" cy="1676400"/>
          </a:xfrm>
          <a:prstGeom prst="rect">
            <a:avLst/>
          </a:prstGeom>
        </p:spPr>
        <p:txBody>
          <a:bodyPr vert="horz" lIns="81043" tIns="40522" rIns="81043" bIns="40522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5"/>
            <a:ext cx="6995160" cy="6638079"/>
          </a:xfrm>
          <a:prstGeom prst="rect">
            <a:avLst/>
          </a:prstGeom>
        </p:spPr>
        <p:txBody>
          <a:bodyPr vert="horz" lIns="81043" tIns="40522" rIns="81043" bIns="4052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50"/>
            <a:ext cx="1813560" cy="535517"/>
          </a:xfrm>
          <a:prstGeom prst="rect">
            <a:avLst/>
          </a:prstGeom>
        </p:spPr>
        <p:txBody>
          <a:bodyPr vert="horz" lIns="81043" tIns="40522" rIns="81043" bIns="40522" rtlCol="0" anchor="ctr"/>
          <a:lstStyle>
            <a:lvl1pPr algn="l">
              <a:defRPr sz="10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05196"/>
            <a:fld id="{56FCD81D-82BC-E942-A183-BDF0C4AE6F7F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05196"/>
              <a:t>10/16/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50"/>
            <a:ext cx="2461260" cy="535517"/>
          </a:xfrm>
          <a:prstGeom prst="rect">
            <a:avLst/>
          </a:prstGeom>
        </p:spPr>
        <p:txBody>
          <a:bodyPr vert="horz" lIns="81043" tIns="40522" rIns="81043" bIns="40522" rtlCol="0" anchor="ctr"/>
          <a:lstStyle>
            <a:lvl1pPr algn="ctr">
              <a:defRPr sz="10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05196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50"/>
            <a:ext cx="1813560" cy="535517"/>
          </a:xfrm>
          <a:prstGeom prst="rect">
            <a:avLst/>
          </a:prstGeom>
        </p:spPr>
        <p:txBody>
          <a:bodyPr vert="horz" lIns="81043" tIns="40522" rIns="81043" bIns="40522" rtlCol="0" anchor="ctr"/>
          <a:lstStyle>
            <a:lvl1pPr algn="r">
              <a:defRPr sz="10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05196"/>
            <a:fld id="{7DB523EE-4891-A148-92D0-C346D550430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405196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125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05196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3898" indent="-303898" algn="l" defTabSz="405196" rtl="0" eaLnBrk="1" latinLnBrk="0" hangingPunct="1">
        <a:spcBef>
          <a:spcPct val="20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445" indent="-253247" algn="l" defTabSz="405196" rtl="0" eaLnBrk="1" latinLnBrk="0" hangingPunct="1">
        <a:spcBef>
          <a:spcPct val="20000"/>
        </a:spcBef>
        <a:buFont typeface="Arial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2992" indent="-202599" algn="l" defTabSz="405196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18187" indent="-202599" algn="l" defTabSz="405196" rtl="0" eaLnBrk="1" latinLnBrk="0" hangingPunct="1">
        <a:spcBef>
          <a:spcPct val="20000"/>
        </a:spcBef>
        <a:buFont typeface="Arial"/>
        <a:buChar char="–"/>
        <a:defRPr sz="1798" kern="1200">
          <a:solidFill>
            <a:schemeClr val="tx1"/>
          </a:solidFill>
          <a:latin typeface="+mn-lt"/>
          <a:ea typeface="+mn-ea"/>
          <a:cs typeface="+mn-cs"/>
        </a:defRPr>
      </a:lvl4pPr>
      <a:lvl5pPr marL="1823386" indent="-202599" algn="l" defTabSz="405196" rtl="0" eaLnBrk="1" latinLnBrk="0" hangingPunct="1">
        <a:spcBef>
          <a:spcPct val="20000"/>
        </a:spcBef>
        <a:buFont typeface="Arial"/>
        <a:buChar char="»"/>
        <a:defRPr sz="1798" kern="1200">
          <a:solidFill>
            <a:schemeClr val="tx1"/>
          </a:solidFill>
          <a:latin typeface="+mn-lt"/>
          <a:ea typeface="+mn-ea"/>
          <a:cs typeface="+mn-cs"/>
        </a:defRPr>
      </a:lvl5pPr>
      <a:lvl6pPr marL="2228582" indent="-202599" algn="l" defTabSz="405196" rtl="0" eaLnBrk="1" latinLnBrk="0" hangingPunct="1">
        <a:spcBef>
          <a:spcPct val="20000"/>
        </a:spcBef>
        <a:buFont typeface="Arial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6pPr>
      <a:lvl7pPr marL="2633778" indent="-202599" algn="l" defTabSz="405196" rtl="0" eaLnBrk="1" latinLnBrk="0" hangingPunct="1">
        <a:spcBef>
          <a:spcPct val="20000"/>
        </a:spcBef>
        <a:buFont typeface="Arial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7pPr>
      <a:lvl8pPr marL="3038976" indent="-202599" algn="l" defTabSz="405196" rtl="0" eaLnBrk="1" latinLnBrk="0" hangingPunct="1">
        <a:spcBef>
          <a:spcPct val="20000"/>
        </a:spcBef>
        <a:buFont typeface="Arial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8pPr>
      <a:lvl9pPr marL="3444172" indent="-202599" algn="l" defTabSz="405196" rtl="0" eaLnBrk="1" latinLnBrk="0" hangingPunct="1">
        <a:spcBef>
          <a:spcPct val="20000"/>
        </a:spcBef>
        <a:buFont typeface="Arial"/>
        <a:buChar char="•"/>
        <a:defRPr sz="17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5196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0394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5590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0786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25983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1180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36377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41573" algn="l" defTabSz="40519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193196" y="1945357"/>
            <a:ext cx="2325211" cy="1015663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2000" b="1" dirty="0">
                <a:solidFill>
                  <a:prstClr val="black"/>
                </a:solidFill>
                <a:latin typeface="Helvetica" pitchFamily="2" charset="0"/>
              </a:rPr>
              <a:t>Supplemental Figure 1. </a:t>
            </a:r>
            <a:r>
              <a:rPr lang="en-US" sz="2000" dirty="0">
                <a:solidFill>
                  <a:prstClr val="black"/>
                </a:solidFill>
                <a:latin typeface="Helvetica" pitchFamily="2" charset="0"/>
              </a:rPr>
              <a:t>Participant flow</a:t>
            </a:r>
          </a:p>
        </p:txBody>
      </p:sp>
      <p:sp>
        <p:nvSpPr>
          <p:cNvPr id="3" name="Rounded Rectangle 2"/>
          <p:cNvSpPr/>
          <p:nvPr/>
        </p:nvSpPr>
        <p:spPr>
          <a:xfrm>
            <a:off x="5255314" y="387061"/>
            <a:ext cx="1701092" cy="241385"/>
          </a:xfrm>
          <a:prstGeom prst="roundRec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255314" y="360757"/>
            <a:ext cx="1748031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200" dirty="0">
                <a:solidFill>
                  <a:prstClr val="black"/>
                </a:solidFill>
                <a:latin typeface="Helvetica" pitchFamily="2" charset="0"/>
              </a:rPr>
              <a:t>Enrollment</a:t>
            </a:r>
          </a:p>
        </p:txBody>
      </p:sp>
      <p:cxnSp>
        <p:nvCxnSpPr>
          <p:cNvPr id="79" name="Straight Arrow Connector 78"/>
          <p:cNvCxnSpPr>
            <a:cxnSpLocks/>
            <a:stCxn id="2" idx="2"/>
          </p:cNvCxnSpPr>
          <p:nvPr/>
        </p:nvCxnSpPr>
        <p:spPr>
          <a:xfrm flipH="1">
            <a:off x="3747889" y="701107"/>
            <a:ext cx="4915" cy="4632893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2690865" y="339448"/>
            <a:ext cx="2123878" cy="36165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06192" y="366836"/>
            <a:ext cx="2261892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latin typeface="Helvetica" pitchFamily="2" charset="0"/>
              </a:rPr>
              <a:t>Screened for eligibility (n=1057)</a:t>
            </a:r>
          </a:p>
        </p:txBody>
      </p:sp>
      <p:sp>
        <p:nvSpPr>
          <p:cNvPr id="20" name="Rectangle 19"/>
          <p:cNvSpPr/>
          <p:nvPr/>
        </p:nvSpPr>
        <p:spPr>
          <a:xfrm>
            <a:off x="4572628" y="875327"/>
            <a:ext cx="2833835" cy="86368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566108" y="833640"/>
            <a:ext cx="2876173" cy="877163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196"/>
            <a:r>
              <a:rPr lang="en-US" sz="1100" dirty="0">
                <a:latin typeface="Helvetica" pitchFamily="2" charset="0"/>
              </a:rPr>
              <a:t>Excluded (n=</a:t>
            </a:r>
            <a:r>
              <a:rPr lang="en-US" sz="1100" dirty="0">
                <a:latin typeface="Helvetica" pitchFamily="2" charset="0"/>
                <a:sym typeface="Wingdings"/>
              </a:rPr>
              <a:t>254</a:t>
            </a:r>
            <a:r>
              <a:rPr lang="en-US" sz="1100" dirty="0">
                <a:latin typeface="Helvetica" pitchFamily="2" charset="0"/>
              </a:rPr>
              <a:t>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100" dirty="0">
                <a:latin typeface="Helvetica" pitchFamily="2" charset="0"/>
              </a:rPr>
              <a:t>Not meeting eligibility criteria (n=69)</a:t>
            </a:r>
          </a:p>
          <a:p>
            <a:pPr marL="710447" lvl="1" indent="-253247" defTabSz="405196">
              <a:buFont typeface="Arial"/>
              <a:buChar char="•"/>
            </a:pPr>
            <a:r>
              <a:rPr lang="en-US" sz="900" dirty="0">
                <a:latin typeface="Helvetica" pitchFamily="2" charset="0"/>
              </a:rPr>
              <a:t>Body mass index ≥40 or &lt;28 (n=60)</a:t>
            </a:r>
          </a:p>
          <a:p>
            <a:pPr marL="710447" lvl="1" indent="-253247" defTabSz="405196">
              <a:buFont typeface="Arial"/>
              <a:buChar char="•"/>
            </a:pPr>
            <a:r>
              <a:rPr lang="en-US" sz="900" dirty="0">
                <a:latin typeface="Helvetica" pitchFamily="2" charset="0"/>
              </a:rPr>
              <a:t>Blood glucose &gt;125mg/dL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100" dirty="0">
                <a:latin typeface="Helvetica" pitchFamily="2" charset="0"/>
              </a:rPr>
              <a:t>Not interested or other (n=185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2696376" y="2936024"/>
            <a:ext cx="2123878" cy="29027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764142" y="2943613"/>
            <a:ext cx="1978575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Randomized (n=632)</a:t>
            </a:r>
          </a:p>
        </p:txBody>
      </p:sp>
      <p:cxnSp>
        <p:nvCxnSpPr>
          <p:cNvPr id="80" name="Straight Arrow Connector 79"/>
          <p:cNvCxnSpPr/>
          <p:nvPr/>
        </p:nvCxnSpPr>
        <p:spPr>
          <a:xfrm>
            <a:off x="3764087" y="1188341"/>
            <a:ext cx="8055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2675198" y="1848263"/>
            <a:ext cx="2123879" cy="29027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690865" y="1845424"/>
            <a:ext cx="2123880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Oriented (n=803)</a:t>
            </a:r>
          </a:p>
        </p:txBody>
      </p:sp>
      <p:cxnSp>
        <p:nvCxnSpPr>
          <p:cNvPr id="58" name="Straight Arrow Connector 57"/>
          <p:cNvCxnSpPr/>
          <p:nvPr/>
        </p:nvCxnSpPr>
        <p:spPr>
          <a:xfrm>
            <a:off x="3747889" y="2555902"/>
            <a:ext cx="8055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>
            <a:off x="4572628" y="2261896"/>
            <a:ext cx="2822555" cy="56923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541240" y="2227280"/>
            <a:ext cx="2371280" cy="600164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Excluded (n=</a:t>
            </a:r>
            <a:r>
              <a:rPr lang="en-US" sz="1100" dirty="0">
                <a:solidFill>
                  <a:prstClr val="black"/>
                </a:solidFill>
                <a:latin typeface="Helvetica" pitchFamily="2" charset="0"/>
                <a:sym typeface="Wingdings"/>
              </a:rPr>
              <a:t>171</a:t>
            </a:r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Not interested (n=142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Other (n=29)</a:t>
            </a:r>
          </a:p>
        </p:txBody>
      </p:sp>
      <p:cxnSp>
        <p:nvCxnSpPr>
          <p:cNvPr id="86" name="Straight Arrow Connector 85"/>
          <p:cNvCxnSpPr/>
          <p:nvPr/>
        </p:nvCxnSpPr>
        <p:spPr>
          <a:xfrm>
            <a:off x="5802339" y="4976155"/>
            <a:ext cx="36262" cy="4140115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1751365" y="4965700"/>
            <a:ext cx="37608" cy="415057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1751365" y="4976156"/>
            <a:ext cx="4050974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ounded Rectangle 10"/>
          <p:cNvSpPr/>
          <p:nvPr/>
        </p:nvSpPr>
        <p:spPr>
          <a:xfrm>
            <a:off x="2797322" y="5194076"/>
            <a:ext cx="1924401" cy="263549"/>
          </a:xfrm>
          <a:prstGeom prst="roundRec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61011" y="5191985"/>
            <a:ext cx="1820597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200" dirty="0">
                <a:solidFill>
                  <a:prstClr val="black"/>
                </a:solidFill>
                <a:latin typeface="Helvetica" pitchFamily="2" charset="0"/>
              </a:rPr>
              <a:t>Allocation</a:t>
            </a:r>
          </a:p>
        </p:txBody>
      </p:sp>
      <p:sp>
        <p:nvSpPr>
          <p:cNvPr id="41" name="Rounded Rectangle 40"/>
          <p:cNvSpPr/>
          <p:nvPr/>
        </p:nvSpPr>
        <p:spPr>
          <a:xfrm>
            <a:off x="2838244" y="5900891"/>
            <a:ext cx="1924396" cy="256040"/>
          </a:xfrm>
          <a:prstGeom prst="roundRec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97322" y="5879931"/>
            <a:ext cx="2030003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200" dirty="0">
                <a:solidFill>
                  <a:prstClr val="black"/>
                </a:solidFill>
                <a:latin typeface="Helvetica" pitchFamily="2" charset="0"/>
              </a:rPr>
              <a:t>Follow-Up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229397" y="6654958"/>
            <a:ext cx="1115351" cy="307777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400" dirty="0">
                <a:solidFill>
                  <a:prstClr val="black"/>
                </a:solidFill>
                <a:latin typeface="Helvetica" pitchFamily="2" charset="0"/>
              </a:rPr>
              <a:t>12 months</a:t>
            </a:r>
          </a:p>
        </p:txBody>
      </p:sp>
      <p:sp>
        <p:nvSpPr>
          <p:cNvPr id="148" name="Rectangle 147"/>
          <p:cNvSpPr/>
          <p:nvPr/>
        </p:nvSpPr>
        <p:spPr>
          <a:xfrm>
            <a:off x="336725" y="6232215"/>
            <a:ext cx="2851641" cy="114753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73437" y="6221344"/>
            <a:ext cx="2778216" cy="107721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Lost to follow-up (n=24)</a:t>
            </a:r>
          </a:p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Discontinued intervention (n=40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Diet (n=5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Health (n=6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Personal (n=21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Schedule (n=8)</a:t>
            </a:r>
          </a:p>
        </p:txBody>
      </p:sp>
      <p:sp>
        <p:nvSpPr>
          <p:cNvPr id="39" name="Rectangle 38"/>
          <p:cNvSpPr/>
          <p:nvPr/>
        </p:nvSpPr>
        <p:spPr>
          <a:xfrm>
            <a:off x="4394927" y="6212508"/>
            <a:ext cx="2851641" cy="11672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4431639" y="6229223"/>
            <a:ext cx="2778216" cy="107721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Lost to follow-up (n=29)</a:t>
            </a:r>
          </a:p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Discontinued intervention (n=37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Diet (n=1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Health (n=11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Personal (n=13)</a:t>
            </a:r>
          </a:p>
          <a:p>
            <a:pPr marL="253247" indent="-253247" defTabSz="405196">
              <a:buFont typeface="Arial"/>
              <a:buChar char="•"/>
            </a:pPr>
            <a:r>
              <a:rPr lang="en-US" sz="1050" dirty="0">
                <a:solidFill>
                  <a:prstClr val="black"/>
                </a:solidFill>
                <a:latin typeface="Helvetica" pitchFamily="2" charset="0"/>
              </a:rPr>
              <a:t>Schedule (n=12)</a:t>
            </a:r>
          </a:p>
        </p:txBody>
      </p:sp>
      <p:sp>
        <p:nvSpPr>
          <p:cNvPr id="87" name="Rectangle 86"/>
          <p:cNvSpPr/>
          <p:nvPr/>
        </p:nvSpPr>
        <p:spPr>
          <a:xfrm>
            <a:off x="336725" y="5532175"/>
            <a:ext cx="2851641" cy="288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34275" y="5521344"/>
            <a:ext cx="2856541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Healthy Low Fat (n=305)</a:t>
            </a:r>
          </a:p>
        </p:txBody>
      </p:sp>
      <p:sp>
        <p:nvSpPr>
          <p:cNvPr id="90" name="Rectangle 89"/>
          <p:cNvSpPr/>
          <p:nvPr/>
        </p:nvSpPr>
        <p:spPr>
          <a:xfrm>
            <a:off x="4394927" y="5530638"/>
            <a:ext cx="2851641" cy="288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392477" y="5519807"/>
            <a:ext cx="2856541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Healthy Low-Carb (n=304)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1121253" y="9169251"/>
            <a:ext cx="1282585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Analyzed (n=224)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4958868" y="9205263"/>
            <a:ext cx="1723759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Analyzed (n=224)</a:t>
            </a:r>
          </a:p>
        </p:txBody>
      </p:sp>
      <p:sp>
        <p:nvSpPr>
          <p:cNvPr id="144" name="Rectangle 143"/>
          <p:cNvSpPr/>
          <p:nvPr/>
        </p:nvSpPr>
        <p:spPr>
          <a:xfrm>
            <a:off x="336725" y="9134160"/>
            <a:ext cx="2851641" cy="34982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45" name="Rectangle 144"/>
          <p:cNvSpPr/>
          <p:nvPr/>
        </p:nvSpPr>
        <p:spPr>
          <a:xfrm>
            <a:off x="4391490" y="9148422"/>
            <a:ext cx="2858515" cy="36291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46" name="Rounded Rectangle 145"/>
          <p:cNvSpPr/>
          <p:nvPr/>
        </p:nvSpPr>
        <p:spPr>
          <a:xfrm>
            <a:off x="2825918" y="8051969"/>
            <a:ext cx="1924396" cy="276999"/>
          </a:xfrm>
          <a:prstGeom prst="roundRect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769073" y="8060590"/>
            <a:ext cx="2030004" cy="276999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212"/>
            <a:r>
              <a:rPr lang="en-US" sz="1200" dirty="0">
                <a:solidFill>
                  <a:prstClr val="black"/>
                </a:solidFill>
                <a:latin typeface="Helvetica" pitchFamily="2" charset="0"/>
              </a:rPr>
              <a:t>Secondary Analysis</a:t>
            </a:r>
          </a:p>
        </p:txBody>
      </p:sp>
      <p:sp>
        <p:nvSpPr>
          <p:cNvPr id="136" name="Rectangle 135"/>
          <p:cNvSpPr/>
          <p:nvPr/>
        </p:nvSpPr>
        <p:spPr>
          <a:xfrm>
            <a:off x="4390123" y="7564872"/>
            <a:ext cx="2861249" cy="3629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404702" y="7610819"/>
            <a:ext cx="2832090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Completed study (n=238)</a:t>
            </a:r>
          </a:p>
        </p:txBody>
      </p:sp>
      <p:sp>
        <p:nvSpPr>
          <p:cNvPr id="138" name="Rectangle 137"/>
          <p:cNvSpPr/>
          <p:nvPr/>
        </p:nvSpPr>
        <p:spPr>
          <a:xfrm>
            <a:off x="340608" y="7575628"/>
            <a:ext cx="2843874" cy="3629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349273" y="7621575"/>
            <a:ext cx="2826544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Completed study (n=241)</a:t>
            </a:r>
          </a:p>
        </p:txBody>
      </p:sp>
      <p:sp>
        <p:nvSpPr>
          <p:cNvPr id="96" name="Rectangle 95"/>
          <p:cNvSpPr/>
          <p:nvPr/>
        </p:nvSpPr>
        <p:spPr>
          <a:xfrm>
            <a:off x="4583577" y="3432902"/>
            <a:ext cx="2794813" cy="74118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541240" y="3395782"/>
            <a:ext cx="2596330" cy="769441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Withdrew prior to receiving diet assignment (n=23)</a:t>
            </a:r>
          </a:p>
          <a:p>
            <a:pPr marL="171442" indent="-171442" defTabSz="405196">
              <a:buFont typeface="Arial"/>
              <a:buChar char="•"/>
            </a:pPr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Scheduling issue (n=14)</a:t>
            </a:r>
          </a:p>
          <a:p>
            <a:pPr marL="171442" indent="-171442" defTabSz="405196">
              <a:buFont typeface="Arial"/>
              <a:buChar char="•"/>
            </a:pPr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Other (n=9)</a:t>
            </a:r>
          </a:p>
        </p:txBody>
      </p:sp>
      <p:cxnSp>
        <p:nvCxnSpPr>
          <p:cNvPr id="99" name="Straight Arrow Connector 98"/>
          <p:cNvCxnSpPr/>
          <p:nvPr/>
        </p:nvCxnSpPr>
        <p:spPr>
          <a:xfrm>
            <a:off x="3760589" y="3820621"/>
            <a:ext cx="80551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3" name="Rectangle 102"/>
          <p:cNvSpPr/>
          <p:nvPr/>
        </p:nvSpPr>
        <p:spPr>
          <a:xfrm>
            <a:off x="2696376" y="4259467"/>
            <a:ext cx="2123878" cy="4692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196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764142" y="4267056"/>
            <a:ext cx="1978575" cy="430887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196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Informed of diet assignment (n=609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9ACF52-666B-5B4A-BC9F-4072B9460266}"/>
              </a:ext>
            </a:extLst>
          </p:cNvPr>
          <p:cNvSpPr txBox="1"/>
          <p:nvPr/>
        </p:nvSpPr>
        <p:spPr>
          <a:xfrm>
            <a:off x="193196" y="204107"/>
            <a:ext cx="26104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0" i="0" u="none" strike="noStrike" dirty="0">
                <a:solidFill>
                  <a:srgbClr val="000000"/>
                </a:solidFill>
                <a:effectLst/>
                <a:latin typeface="Helvetica" pitchFamily="2" charset="0"/>
              </a:rPr>
              <a:t>Michelle E. Hauser et al. Association between Dietary Adherence and Dietary Quality with Weight Loss Success among those Following Low-Carbohydrate and Low-Fat Diets: A Secondary Analysis of the DIETFITS Randomized Clinical Trial </a:t>
            </a:r>
            <a:endParaRPr lang="en-US" sz="900" dirty="0">
              <a:latin typeface="Helvetica" pitchFamily="2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8540FC8-B598-BA07-B251-AE9897661B1C}"/>
              </a:ext>
            </a:extLst>
          </p:cNvPr>
          <p:cNvSpPr/>
          <p:nvPr/>
        </p:nvSpPr>
        <p:spPr>
          <a:xfrm>
            <a:off x="4390123" y="8450301"/>
            <a:ext cx="2861249" cy="3629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EB87609-97E2-07CD-0E50-2905C24C4721}"/>
              </a:ext>
            </a:extLst>
          </p:cNvPr>
          <p:cNvSpPr/>
          <p:nvPr/>
        </p:nvSpPr>
        <p:spPr>
          <a:xfrm>
            <a:off x="340608" y="8461057"/>
            <a:ext cx="2843874" cy="3629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05212"/>
            <a:endParaRPr lang="en-US" sz="1400">
              <a:solidFill>
                <a:prstClr val="white"/>
              </a:solidFill>
              <a:latin typeface="Helvetica" pitchFamily="2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02A945-F922-9952-64F6-82AE314C13AD}"/>
              </a:ext>
            </a:extLst>
          </p:cNvPr>
          <p:cNvSpPr txBox="1"/>
          <p:nvPr/>
        </p:nvSpPr>
        <p:spPr>
          <a:xfrm>
            <a:off x="4404702" y="8488691"/>
            <a:ext cx="2832090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Missing diet assessment (n=14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4B8170-8650-2204-CDBC-48C7398C2A9D}"/>
              </a:ext>
            </a:extLst>
          </p:cNvPr>
          <p:cNvSpPr txBox="1"/>
          <p:nvPr/>
        </p:nvSpPr>
        <p:spPr>
          <a:xfrm>
            <a:off x="346500" y="8489951"/>
            <a:ext cx="2832090" cy="2616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 defTabSz="405212"/>
            <a:r>
              <a:rPr lang="en-US" sz="1100" dirty="0">
                <a:solidFill>
                  <a:prstClr val="black"/>
                </a:solidFill>
                <a:latin typeface="Helvetica" pitchFamily="2" charset="0"/>
              </a:rPr>
              <a:t>Missing diet assessment (n=17)</a:t>
            </a:r>
          </a:p>
        </p:txBody>
      </p:sp>
    </p:spTree>
    <p:extLst>
      <p:ext uri="{BB962C8B-B14F-4D97-AF65-F5344CB8AC3E}">
        <p14:creationId xmlns:p14="http://schemas.microsoft.com/office/powerpoint/2010/main" val="53518120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3</TotalTime>
  <Words>299</Words>
  <Application>Microsoft Macintosh PowerPoint</Application>
  <PresentationFormat>Custom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le Hauser</dc:creator>
  <cp:lastModifiedBy>Christopher Gardner</cp:lastModifiedBy>
  <cp:revision>17</cp:revision>
  <dcterms:created xsi:type="dcterms:W3CDTF">2016-10-06T18:29:59Z</dcterms:created>
  <dcterms:modified xsi:type="dcterms:W3CDTF">2023-10-17T03:57:40Z</dcterms:modified>
</cp:coreProperties>
</file>